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9929813" cy="67976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schula, CH, Dr &lt;kaschula@sun.ac.za&gt;" initials="KCD&lt;" lastIdx="3" clrIdx="0">
    <p:extLst/>
  </p:cmAuthor>
  <p:cmAuthor id="2" name="Georgia Schafer" initials="GS" lastIdx="1" clrIdx="1">
    <p:extLst/>
  </p:cmAuthor>
  <p:cmAuthor id="3" name="Chris Barnett" initials="CB" lastIdx="3" clrIdx="2">
    <p:extLst>
      <p:ext uri="{19B8F6BF-5375-455C-9EA6-DF929625EA0E}">
        <p15:presenceInfo xmlns:p15="http://schemas.microsoft.com/office/powerpoint/2012/main" userId="S-1-5-21-3848398101-821531346-3615173760-100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501" autoAdjust="0"/>
    <p:restoredTop sz="94366" autoAdjust="0"/>
  </p:normalViewPr>
  <p:slideViewPr>
    <p:cSldViewPr>
      <p:cViewPr varScale="1">
        <p:scale>
          <a:sx n="65" d="100"/>
          <a:sy n="65" d="100"/>
        </p:scale>
        <p:origin x="980" y="4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2919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4597" y="0"/>
            <a:ext cx="4302919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9EDF8B-D80C-40C0-9EA1-60E30FC7C958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435350" y="849313"/>
            <a:ext cx="3059113" cy="22939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Z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2982" y="3271381"/>
            <a:ext cx="7943850" cy="267658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6456612"/>
            <a:ext cx="4302919" cy="3410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4597" y="6456612"/>
            <a:ext cx="4302919" cy="3410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1618F-7F06-49A1-A3D1-BB24EAAEDC2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353051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435350" y="849313"/>
            <a:ext cx="3059113" cy="229393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Z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831618F-7F06-49A1-A3D1-BB24EAAEDC21}" type="slidenum">
              <a:rPr lang="en-ZA" smtClean="0"/>
              <a:t>1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2650756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12389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5941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783669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911852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1315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72233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42241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64133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278754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21367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71831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700257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/>
          <p:cNvSpPr txBox="1"/>
          <p:nvPr/>
        </p:nvSpPr>
        <p:spPr>
          <a:xfrm>
            <a:off x="2267744" y="1628800"/>
            <a:ext cx="4421403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900" dirty="0"/>
              <a:t>According to </a:t>
            </a:r>
            <a:r>
              <a:rPr lang="en-ZA" sz="900" dirty="0" err="1"/>
              <a:t>Expasy</a:t>
            </a:r>
            <a:r>
              <a:rPr lang="en-ZA" sz="900" dirty="0"/>
              <a:t> peptide software: the predicted mass of fragment </a:t>
            </a:r>
            <a:r>
              <a:rPr lang="en-ZA" sz="900" b="1" dirty="0"/>
              <a:t>QVQSLTCEVDALK :</a:t>
            </a:r>
            <a:r>
              <a:rPr lang="en-ZA" sz="900" dirty="0"/>
              <a:t> </a:t>
            </a:r>
          </a:p>
          <a:p>
            <a:r>
              <a:rPr lang="en-ZA" sz="900" dirty="0"/>
              <a:t>[M] = 1432.7232</a:t>
            </a:r>
          </a:p>
          <a:p>
            <a:r>
              <a:rPr lang="en-ZA" sz="900" dirty="0"/>
              <a:t>[M+H]+ = 1433.7304</a:t>
            </a:r>
          </a:p>
          <a:p>
            <a:r>
              <a:rPr lang="en-ZA" sz="900" dirty="0"/>
              <a:t>[M+2H]2+ = 717.3688</a:t>
            </a:r>
          </a:p>
          <a:p>
            <a:endParaRPr lang="en-ZA" sz="900" dirty="0"/>
          </a:p>
          <a:p>
            <a:r>
              <a:rPr lang="en-ZA" sz="900" dirty="0"/>
              <a:t>We found the parent ion to be carrying a 2+ charge= [M + 2H]2+ = 717.3689</a:t>
            </a:r>
          </a:p>
          <a:p>
            <a:r>
              <a:rPr lang="en-ZA" sz="900" dirty="0"/>
              <a:t>Therefore for modified fragment we expect: </a:t>
            </a:r>
          </a:p>
          <a:p>
            <a:r>
              <a:rPr lang="en-ZA" sz="900" dirty="0"/>
              <a:t>ZA (1432.7233 + 72.00337 + 2x1.0078)/2 = 753.3711</a:t>
            </a:r>
          </a:p>
          <a:p>
            <a:r>
              <a:rPr lang="en-ZA" sz="900" dirty="0"/>
              <a:t>DP (1432.7233 + 322.08096 + 2x1.0078)/2 = 878.4099</a:t>
            </a:r>
          </a:p>
          <a:p>
            <a:endParaRPr lang="en-ZA" sz="1350" dirty="0"/>
          </a:p>
          <a:p>
            <a:endParaRPr lang="en-ZA" sz="1350" dirty="0"/>
          </a:p>
        </p:txBody>
      </p:sp>
      <p:graphicFrame>
        <p:nvGraphicFramePr>
          <p:cNvPr id="21" name="Table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65489692"/>
              </p:ext>
            </p:extLst>
          </p:nvPr>
        </p:nvGraphicFramePr>
        <p:xfrm>
          <a:off x="2577613" y="3189647"/>
          <a:ext cx="3847623" cy="1012128"/>
        </p:xfrm>
        <a:graphic>
          <a:graphicData uri="http://schemas.openxmlformats.org/drawingml/2006/table">
            <a:tbl>
              <a:tblPr firstRow="1" firstCol="1" bandRow="1"/>
              <a:tblGrid>
                <a:gridCol w="128254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8254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8254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89179"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ZA" sz="8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ZA" sz="8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ZA" sz="8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Sample</a:t>
                      </a:r>
                      <a:endParaRPr lang="en-ZA" sz="8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1435" marR="5143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ZA" sz="8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[M + 2H]</a:t>
                      </a:r>
                      <a:r>
                        <a:rPr lang="en-ZA" sz="800" baseline="30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2+</a:t>
                      </a:r>
                      <a:endParaRPr lang="en-ZA" sz="8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ZA" sz="8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ZA" sz="8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1435" marR="5143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9179">
                <a:tc v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ZA" sz="8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Predicted </a:t>
                      </a:r>
                      <a:r>
                        <a:rPr lang="en-ZA" sz="800" i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m</a:t>
                      </a:r>
                      <a:r>
                        <a:rPr lang="en-ZA" sz="8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/</a:t>
                      </a:r>
                      <a:r>
                        <a:rPr lang="en-ZA" sz="800" i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z</a:t>
                      </a:r>
                      <a:endParaRPr lang="en-ZA" sz="800" i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ZA" sz="8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ZA" sz="8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1435" marR="5143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ZA" sz="8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Found </a:t>
                      </a:r>
                      <a:r>
                        <a:rPr lang="en-ZA" sz="800" i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m</a:t>
                      </a:r>
                      <a:r>
                        <a:rPr lang="en-ZA" sz="8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/</a:t>
                      </a:r>
                      <a:r>
                        <a:rPr lang="en-ZA" sz="800" i="1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z</a:t>
                      </a:r>
                      <a:endParaRPr lang="en-ZA" sz="800" i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1435" marR="5143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5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ZA" sz="800">
                          <a:effectLst/>
                          <a:latin typeface="Arial"/>
                          <a:ea typeface="Calibri"/>
                          <a:cs typeface="Times New Roman"/>
                        </a:rPr>
                        <a:t>Vimentin (untreated)</a:t>
                      </a:r>
                      <a:endParaRPr lang="en-ZA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1435" marR="5143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ZA" sz="800">
                          <a:effectLst/>
                          <a:latin typeface="Arial"/>
                          <a:ea typeface="Calibri"/>
                          <a:cs typeface="Times New Roman"/>
                        </a:rPr>
                        <a:t>717.3688</a:t>
                      </a:r>
                      <a:endParaRPr lang="en-ZA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1435" marR="5143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ZA" sz="800">
                          <a:effectLst/>
                          <a:latin typeface="Arial"/>
                          <a:ea typeface="Calibri"/>
                          <a:cs typeface="Times New Roman"/>
                        </a:rPr>
                        <a:t>717.3689</a:t>
                      </a:r>
                      <a:endParaRPr lang="en-ZA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1435" marR="5143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5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ZA" sz="800">
                          <a:effectLst/>
                          <a:latin typeface="Arial"/>
                          <a:ea typeface="Calibri"/>
                          <a:cs typeface="Times New Roman"/>
                        </a:rPr>
                        <a:t>Vimentin + ZA</a:t>
                      </a:r>
                      <a:endParaRPr lang="en-ZA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1435" marR="5143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ZA" sz="8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753.3711</a:t>
                      </a:r>
                      <a:endParaRPr lang="en-ZA" sz="8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1435" marR="5143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ZA" sz="800">
                          <a:effectLst/>
                          <a:latin typeface="Arial"/>
                          <a:ea typeface="Calibri"/>
                          <a:cs typeface="Times New Roman"/>
                        </a:rPr>
                        <a:t>753.3708</a:t>
                      </a:r>
                      <a:endParaRPr lang="en-ZA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1435" marR="5143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59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ZA" sz="800">
                          <a:effectLst/>
                          <a:latin typeface="Arial"/>
                          <a:ea typeface="Calibri"/>
                          <a:cs typeface="Times New Roman"/>
                        </a:rPr>
                        <a:t>Vimentin + DP</a:t>
                      </a:r>
                      <a:endParaRPr lang="en-ZA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1435" marR="5143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ZA" sz="800">
                          <a:effectLst/>
                          <a:latin typeface="Arial"/>
                          <a:ea typeface="Calibri"/>
                          <a:cs typeface="Times New Roman"/>
                        </a:rPr>
                        <a:t>878.4099</a:t>
                      </a:r>
                      <a:endParaRPr lang="en-ZA" sz="8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1435" marR="5143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ZA" sz="8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878.4096</a:t>
                      </a:r>
                      <a:endParaRPr lang="en-ZA" sz="8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1435" marR="5143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22" name="Rectangle 21"/>
          <p:cNvSpPr/>
          <p:nvPr/>
        </p:nvSpPr>
        <p:spPr>
          <a:xfrm>
            <a:off x="2483768" y="3132497"/>
            <a:ext cx="4026293" cy="1134126"/>
          </a:xfrm>
          <a:prstGeom prst="rect">
            <a:avLst/>
          </a:prstGeom>
          <a:noFill/>
          <a:ln w="50800" cmpd="tri"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 sz="1350"/>
          </a:p>
        </p:txBody>
      </p:sp>
      <p:sp>
        <p:nvSpPr>
          <p:cNvPr id="2" name="TextBox 1"/>
          <p:cNvSpPr txBox="1"/>
          <p:nvPr/>
        </p:nvSpPr>
        <p:spPr>
          <a:xfrm>
            <a:off x="3995936" y="745303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en-ZA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56789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50</TotalTime>
  <Words>105</Words>
  <Application>Microsoft Office PowerPoint</Application>
  <PresentationFormat>On-screen Show (4:3)</PresentationFormat>
  <Paragraphs>2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University of Cape Tow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therine</dc:creator>
  <cp:lastModifiedBy>Kaschula, CH, Dr &lt;kaschula@sun.ac.za&gt;</cp:lastModifiedBy>
  <cp:revision>102</cp:revision>
  <cp:lastPrinted>2017-12-11T11:23:10Z</cp:lastPrinted>
  <dcterms:created xsi:type="dcterms:W3CDTF">2015-06-09T13:18:46Z</dcterms:created>
  <dcterms:modified xsi:type="dcterms:W3CDTF">2019-01-31T11:22:40Z</dcterms:modified>
</cp:coreProperties>
</file>